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>
        <p:scale>
          <a:sx n="50" d="100"/>
          <a:sy n="50" d="100"/>
        </p:scale>
        <p:origin x="29" y="7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7180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991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2028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647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298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6151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8067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6010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7930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398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6779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31FAE-3968-4B9D-83EA-2AD1CEEE46C7}" type="datetimeFigureOut">
              <a:rPr lang="zh-CN" altLang="en-US" smtClean="0"/>
              <a:t>2024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7CFD-72FA-4873-BB7A-661101FD50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435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图片 3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8833" y="-393954"/>
            <a:ext cx="5168188" cy="7106259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87830B8C-83E9-4C3C-BEC2-4DF3E10EB11F}"/>
              </a:ext>
            </a:extLst>
          </p:cNvPr>
          <p:cNvSpPr/>
          <p:nvPr/>
        </p:nvSpPr>
        <p:spPr>
          <a:xfrm>
            <a:off x="1983540" y="1012959"/>
            <a:ext cx="127646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3092037" y="5065566"/>
            <a:ext cx="585417" cy="276999"/>
            <a:chOff x="-4002962" y="10215563"/>
            <a:chExt cx="585417" cy="276999"/>
          </a:xfrm>
        </p:grpSpPr>
        <p:sp>
          <p:nvSpPr>
            <p:cNvPr id="13" name="矩形 12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>
            <a:off x="3117433" y="5667971"/>
            <a:ext cx="585417" cy="276999"/>
            <a:chOff x="-4002962" y="10215563"/>
            <a:chExt cx="585417" cy="276999"/>
          </a:xfrm>
        </p:grpSpPr>
        <p:sp>
          <p:nvSpPr>
            <p:cNvPr id="16" name="矩形 15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" name="组合 17"/>
          <p:cNvGrpSpPr/>
          <p:nvPr/>
        </p:nvGrpSpPr>
        <p:grpSpPr>
          <a:xfrm>
            <a:off x="3102337" y="4601313"/>
            <a:ext cx="580831" cy="276999"/>
            <a:chOff x="-4002962" y="10215563"/>
            <a:chExt cx="580831" cy="276999"/>
          </a:xfrm>
        </p:grpSpPr>
        <p:sp>
          <p:nvSpPr>
            <p:cNvPr id="19" name="矩形 18"/>
            <p:cNvSpPr/>
            <p:nvPr/>
          </p:nvSpPr>
          <p:spPr>
            <a:xfrm>
              <a:off x="-4002962" y="10215563"/>
              <a:ext cx="54213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40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" name="组合 29"/>
          <p:cNvGrpSpPr/>
          <p:nvPr/>
        </p:nvGrpSpPr>
        <p:grpSpPr>
          <a:xfrm>
            <a:off x="4142623" y="4193528"/>
            <a:ext cx="1199192" cy="1097757"/>
            <a:chOff x="5203042" y="3239581"/>
            <a:chExt cx="1199192" cy="1097757"/>
          </a:xfrm>
        </p:grpSpPr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B63470F8-8068-46C9-901B-86F7AE62C14B}"/>
                </a:ext>
              </a:extLst>
            </p:cNvPr>
            <p:cNvCxnSpPr>
              <a:cxnSpLocks/>
            </p:cNvCxnSpPr>
            <p:nvPr/>
          </p:nvCxnSpPr>
          <p:spPr>
            <a:xfrm>
              <a:off x="5203042" y="3776225"/>
              <a:ext cx="117000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E1DB421E-9ACF-464C-8ACB-D1AB43B55ABB}"/>
                </a:ext>
              </a:extLst>
            </p:cNvPr>
            <p:cNvSpPr/>
            <p:nvPr/>
          </p:nvSpPr>
          <p:spPr>
            <a:xfrm>
              <a:off x="5389126" y="3475489"/>
              <a:ext cx="79592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YAPC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4948410" y="3603794"/>
              <a:ext cx="10977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5487995" y="3836899"/>
              <a:ext cx="599973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5876547" y="3798468"/>
              <a:ext cx="682042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矩形 20"/>
          <p:cNvSpPr/>
          <p:nvPr/>
        </p:nvSpPr>
        <p:spPr>
          <a:xfrm>
            <a:off x="4165600" y="5204413"/>
            <a:ext cx="1147023" cy="231188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7842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46" r="1178"/>
          <a:stretch/>
        </p:blipFill>
        <p:spPr>
          <a:xfrm flipH="1">
            <a:off x="2659083" y="-2276768"/>
            <a:ext cx="6562165" cy="9134768"/>
          </a:xfrm>
          <a:prstGeom prst="rect">
            <a:avLst/>
          </a:prstGeom>
        </p:spPr>
      </p:pic>
      <p:grpSp>
        <p:nvGrpSpPr>
          <p:cNvPr id="11" name="组合 10"/>
          <p:cNvGrpSpPr/>
          <p:nvPr/>
        </p:nvGrpSpPr>
        <p:grpSpPr>
          <a:xfrm>
            <a:off x="3825286" y="5439341"/>
            <a:ext cx="670376" cy="276999"/>
            <a:chOff x="-4088306" y="10215563"/>
            <a:chExt cx="670376" cy="276999"/>
          </a:xfrm>
        </p:grpSpPr>
        <p:sp>
          <p:nvSpPr>
            <p:cNvPr id="12" name="矩形 11"/>
            <p:cNvSpPr/>
            <p:nvPr/>
          </p:nvSpPr>
          <p:spPr>
            <a:xfrm>
              <a:off x="-4088306" y="10215563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>
            <a:off x="6239362" y="3877822"/>
            <a:ext cx="1199192" cy="1097757"/>
            <a:chOff x="5203042" y="3239581"/>
            <a:chExt cx="1199192" cy="1097757"/>
          </a:xfrm>
        </p:grpSpPr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B63470F8-8068-46C9-901B-86F7AE62C14B}"/>
                </a:ext>
              </a:extLst>
            </p:cNvPr>
            <p:cNvCxnSpPr>
              <a:cxnSpLocks/>
            </p:cNvCxnSpPr>
            <p:nvPr/>
          </p:nvCxnSpPr>
          <p:spPr>
            <a:xfrm>
              <a:off x="5203042" y="3776225"/>
              <a:ext cx="117000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E1DB421E-9ACF-464C-8ACB-D1AB43B55ABB}"/>
                </a:ext>
              </a:extLst>
            </p:cNvPr>
            <p:cNvSpPr/>
            <p:nvPr/>
          </p:nvSpPr>
          <p:spPr>
            <a:xfrm>
              <a:off x="5389126" y="3475489"/>
              <a:ext cx="79592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YAPC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4948410" y="3603794"/>
              <a:ext cx="10977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5487995" y="3836899"/>
              <a:ext cx="599973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5876547" y="3798468"/>
              <a:ext cx="682042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矩形 21">
            <a:extLst>
              <a:ext uri="{FF2B5EF4-FFF2-40B4-BE49-F238E27FC236}">
                <a16:creationId xmlns:a16="http://schemas.microsoft.com/office/drawing/2014/main" id="{87830B8C-83E9-4C3C-BEC2-4DF3E10EB11F}"/>
              </a:ext>
            </a:extLst>
          </p:cNvPr>
          <p:cNvSpPr/>
          <p:nvPr/>
        </p:nvSpPr>
        <p:spPr>
          <a:xfrm>
            <a:off x="1382621" y="1606255"/>
            <a:ext cx="127646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RKD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6168285" y="4875196"/>
            <a:ext cx="1332779" cy="396106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0309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7431" y="-2157826"/>
            <a:ext cx="6556964" cy="9015826"/>
          </a:xfrm>
          <a:prstGeom prst="rect">
            <a:avLst/>
          </a:prstGeom>
        </p:spPr>
      </p:pic>
      <p:grpSp>
        <p:nvGrpSpPr>
          <p:cNvPr id="12" name="组合 11"/>
          <p:cNvGrpSpPr/>
          <p:nvPr/>
        </p:nvGrpSpPr>
        <p:grpSpPr>
          <a:xfrm>
            <a:off x="2911256" y="5324469"/>
            <a:ext cx="670376" cy="276999"/>
            <a:chOff x="-4088306" y="10215563"/>
            <a:chExt cx="670376" cy="276999"/>
          </a:xfrm>
        </p:grpSpPr>
        <p:sp>
          <p:nvSpPr>
            <p:cNvPr id="13" name="矩形 12"/>
            <p:cNvSpPr/>
            <p:nvPr/>
          </p:nvSpPr>
          <p:spPr>
            <a:xfrm>
              <a:off x="-4088306" y="10215563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" name="组合 20"/>
          <p:cNvGrpSpPr/>
          <p:nvPr/>
        </p:nvGrpSpPr>
        <p:grpSpPr>
          <a:xfrm>
            <a:off x="5203042" y="3239581"/>
            <a:ext cx="1199192" cy="1097757"/>
            <a:chOff x="5203042" y="3239581"/>
            <a:chExt cx="1199192" cy="1097757"/>
          </a:xfrm>
        </p:grpSpPr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B63470F8-8068-46C9-901B-86F7AE62C14B}"/>
                </a:ext>
              </a:extLst>
            </p:cNvPr>
            <p:cNvCxnSpPr>
              <a:cxnSpLocks/>
            </p:cNvCxnSpPr>
            <p:nvPr/>
          </p:nvCxnSpPr>
          <p:spPr>
            <a:xfrm>
              <a:off x="5203042" y="3776225"/>
              <a:ext cx="117000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E1DB421E-9ACF-464C-8ACB-D1AB43B55ABB}"/>
                </a:ext>
              </a:extLst>
            </p:cNvPr>
            <p:cNvSpPr/>
            <p:nvPr/>
          </p:nvSpPr>
          <p:spPr>
            <a:xfrm>
              <a:off x="5389126" y="3475489"/>
              <a:ext cx="79592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YAPC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4948410" y="3603794"/>
              <a:ext cx="10977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5487995" y="3836899"/>
              <a:ext cx="599973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5876547" y="3798468"/>
              <a:ext cx="682042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0" name="图片 29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96877" y="-2157826"/>
            <a:ext cx="6556964" cy="9015826"/>
          </a:xfrm>
          <a:prstGeom prst="rect">
            <a:avLst/>
          </a:prstGeom>
        </p:spPr>
      </p:pic>
      <p:sp>
        <p:nvSpPr>
          <p:cNvPr id="31" name="矩形 30"/>
          <p:cNvSpPr/>
          <p:nvPr/>
        </p:nvSpPr>
        <p:spPr>
          <a:xfrm>
            <a:off x="2122436" y="1092112"/>
            <a:ext cx="175778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-PRKDC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Ser2056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4998721" y="4567641"/>
            <a:ext cx="1511322" cy="537759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11589390" y="4567641"/>
            <a:ext cx="1511322" cy="537759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087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图片 3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8400" y="-2161540"/>
            <a:ext cx="6672596" cy="9174820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327145F1-DEF5-43BB-BF9A-9191F1AFAE2D}"/>
              </a:ext>
            </a:extLst>
          </p:cNvPr>
          <p:cNvSpPr/>
          <p:nvPr/>
        </p:nvSpPr>
        <p:spPr>
          <a:xfrm>
            <a:off x="2076138" y="1027337"/>
            <a:ext cx="68480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 flipH="1">
            <a:off x="7835859" y="4360538"/>
            <a:ext cx="585417" cy="276999"/>
            <a:chOff x="-4002962" y="10215563"/>
            <a:chExt cx="585417" cy="276999"/>
          </a:xfrm>
        </p:grpSpPr>
        <p:sp>
          <p:nvSpPr>
            <p:cNvPr id="13" name="矩形 12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1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 flipH="1">
            <a:off x="7860911" y="4831440"/>
            <a:ext cx="585417" cy="276999"/>
            <a:chOff x="-4002962" y="10215563"/>
            <a:chExt cx="585417" cy="276999"/>
          </a:xfrm>
        </p:grpSpPr>
        <p:sp>
          <p:nvSpPr>
            <p:cNvPr id="16" name="矩形 15"/>
            <p:cNvSpPr/>
            <p:nvPr/>
          </p:nvSpPr>
          <p:spPr>
            <a:xfrm>
              <a:off x="-4002962" y="10215563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" name="组合 21"/>
          <p:cNvGrpSpPr/>
          <p:nvPr/>
        </p:nvGrpSpPr>
        <p:grpSpPr>
          <a:xfrm flipH="1">
            <a:off x="7818902" y="3873745"/>
            <a:ext cx="685002" cy="276999"/>
            <a:chOff x="-4107133" y="10215563"/>
            <a:chExt cx="685002" cy="276999"/>
          </a:xfrm>
        </p:grpSpPr>
        <p:sp>
          <p:nvSpPr>
            <p:cNvPr id="23" name="矩形 22"/>
            <p:cNvSpPr/>
            <p:nvPr/>
          </p:nvSpPr>
          <p:spPr>
            <a:xfrm>
              <a:off x="-4107133" y="10215563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直接连接符 23"/>
            <p:cNvCxnSpPr/>
            <p:nvPr/>
          </p:nvCxnSpPr>
          <p:spPr>
            <a:xfrm>
              <a:off x="-3494131" y="10354409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" name="组合 24"/>
          <p:cNvGrpSpPr/>
          <p:nvPr/>
        </p:nvGrpSpPr>
        <p:grpSpPr>
          <a:xfrm>
            <a:off x="5203042" y="3239581"/>
            <a:ext cx="1199192" cy="1097757"/>
            <a:chOff x="5203042" y="3239581"/>
            <a:chExt cx="1199192" cy="1097757"/>
          </a:xfrm>
        </p:grpSpPr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B63470F8-8068-46C9-901B-86F7AE62C14B}"/>
                </a:ext>
              </a:extLst>
            </p:cNvPr>
            <p:cNvCxnSpPr>
              <a:cxnSpLocks/>
            </p:cNvCxnSpPr>
            <p:nvPr/>
          </p:nvCxnSpPr>
          <p:spPr>
            <a:xfrm>
              <a:off x="5203042" y="3776225"/>
              <a:ext cx="1170000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E1DB421E-9ACF-464C-8ACB-D1AB43B55ABB}"/>
                </a:ext>
              </a:extLst>
            </p:cNvPr>
            <p:cNvSpPr/>
            <p:nvPr/>
          </p:nvSpPr>
          <p:spPr>
            <a:xfrm>
              <a:off x="5389126" y="3475489"/>
              <a:ext cx="79592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YAPC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4948410" y="3603794"/>
              <a:ext cx="10977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5487995" y="3836899"/>
              <a:ext cx="599973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2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7ED4BE5C-CEFD-4FEE-B154-600181E1D326}"/>
                </a:ext>
              </a:extLst>
            </p:cNvPr>
            <p:cNvSpPr/>
            <p:nvPr/>
          </p:nvSpPr>
          <p:spPr>
            <a:xfrm rot="17430996">
              <a:off x="5876547" y="3798468"/>
              <a:ext cx="682042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ctr"/>
              <a:r>
                <a:rPr lang="en-US" altLang="zh-CN" sz="1800" dirty="0" err="1">
                  <a:latin typeface="Arial" panose="020B0604020202020204" pitchFamily="34" charset="0"/>
                  <a:cs typeface="Arial" panose="020B0604020202020204" pitchFamily="34" charset="0"/>
                </a:rPr>
                <a:t>sg3</a:t>
              </a:r>
              <a:endParaRPr lang="en-US" altLang="zh-CN" sz="1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2" name="直接箭头连接符 31"/>
          <p:cNvCxnSpPr/>
          <p:nvPr/>
        </p:nvCxnSpPr>
        <p:spPr>
          <a:xfrm flipH="1">
            <a:off x="7818902" y="4617217"/>
            <a:ext cx="94487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矩形 19"/>
          <p:cNvSpPr/>
          <p:nvPr/>
        </p:nvSpPr>
        <p:spPr>
          <a:xfrm>
            <a:off x="5131965" y="4479983"/>
            <a:ext cx="1332779" cy="306155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1947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35</Words>
  <Application>Microsoft Office PowerPoint</Application>
  <PresentationFormat>宽屏</PresentationFormat>
  <Paragraphs>28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10</cp:revision>
  <dcterms:created xsi:type="dcterms:W3CDTF">2024-02-08T04:45:53Z</dcterms:created>
  <dcterms:modified xsi:type="dcterms:W3CDTF">2024-02-12T00:36:51Z</dcterms:modified>
</cp:coreProperties>
</file>